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90FEB-D097-4D9C-85DF-150344FB8C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2546F-25EB-4CEA-96C6-9F76EAA153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135259-C8F2-4B43-BD52-46A9D236D7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19271-8BBF-451C-BFE2-9ED5755FED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36AA2-F512-4523-BCED-A43DE81ADE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E2700-CB2F-41DC-BDC5-C7EC170FE8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2DDB8-03A3-4267-9E4E-96FD104C99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E474C-6489-4D6C-82C5-438ABAE60A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78A14-4133-46EE-A287-028194C38D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547AA-C6E1-4F65-ACA0-49A45336A7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A47CF-26FD-440C-8A20-41AF6CC30C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19BC7-F379-4569-B9E2-B97840C048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77D6C1-B388-4A41-A5DC-4EB312E850D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730080"/>
            <a:ext cx="2514600" cy="43434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380880" y="762120"/>
            <a:ext cx="8153640" cy="5003640"/>
            <a:chOff x="380880" y="762120"/>
            <a:chExt cx="8153640" cy="5003640"/>
          </a:xfrm>
        </p:grpSpPr>
        <p:grpSp>
          <p:nvGrpSpPr>
            <p:cNvPr id="43" name=""/>
            <p:cNvGrpSpPr/>
            <p:nvPr/>
          </p:nvGrpSpPr>
          <p:grpSpPr>
            <a:xfrm>
              <a:off x="380880" y="1339920"/>
              <a:ext cx="2286000" cy="1218600"/>
              <a:chOff x="380880" y="1339920"/>
              <a:chExt cx="2286000" cy="1218600"/>
            </a:xfrm>
          </p:grpSpPr>
          <p:sp>
            <p:nvSpPr>
              <p:cNvPr id="44" name=""/>
              <p:cNvSpPr/>
              <p:nvPr/>
            </p:nvSpPr>
            <p:spPr>
              <a:xfrm>
                <a:off x="1447920" y="2253960"/>
                <a:ext cx="0" cy="304560"/>
              </a:xfrm>
              <a:prstGeom prst="line">
                <a:avLst/>
              </a:prstGeom>
              <a:ln w="38160">
                <a:solidFill>
                  <a:srgbClr val="f9340d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380880" y="1339920"/>
                <a:ext cx="2286000" cy="824040"/>
              </a:xfrm>
              <a:prstGeom prst="rect">
                <a:avLst/>
              </a:prstGeom>
              <a:solidFill>
                <a:srgbClr val="ff99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300"/>
                  </a:spcBef>
                  <a:tabLst>
                    <a:tab algn="l" pos="0"/>
                    <a:tab algn="l" pos="893880"/>
                    <a:tab algn="l" pos="1787400"/>
                    <a:tab algn="l" pos="2681280"/>
                    <a:tab algn="l" pos="3575160"/>
                    <a:tab algn="l" pos="4468680"/>
                    <a:tab algn="l" pos="5362560"/>
                    <a:tab algn="l" pos="6256440"/>
                    <a:tab algn="l" pos="7149960"/>
                    <a:tab algn="l" pos="8043840"/>
                    <a:tab algn="l" pos="8937720"/>
                    <a:tab algn="l" pos="9831240"/>
                    <a:tab algn="l" pos="10725120"/>
                  </a:tabLst>
                </a:pPr>
                <a:r>
                  <a:rPr b="0" lang="en-US" sz="1200" spc="-1" strike="noStrike">
                    <a:solidFill>
                      <a:srgbClr val="333399"/>
                    </a:solidFill>
                    <a:latin typeface="Arial"/>
                  </a:rPr>
                  <a:t>Root cDNA library preparation for untreated (water) and salt challenged plants (treated at  150mM NaCl for 2.0 hrs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" name=""/>
            <p:cNvSpPr/>
            <p:nvPr/>
          </p:nvSpPr>
          <p:spPr>
            <a:xfrm>
              <a:off x="1447920" y="3517920"/>
              <a:ext cx="0" cy="277920"/>
            </a:xfrm>
            <a:prstGeom prst="line">
              <a:avLst/>
            </a:prstGeom>
            <a:ln w="38160">
              <a:solidFill>
                <a:srgbClr val="f9340d"/>
              </a:solidFill>
              <a:miter/>
              <a:tail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80880" y="2590920"/>
              <a:ext cx="2286000" cy="100656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Cloning of the library into yeast expression vector and amplification of the libraries on </a:t>
              </a:r>
              <a:r>
                <a:rPr b="0" i="1" lang="en-US" sz="1200" spc="-1" strike="noStrike">
                  <a:solidFill>
                    <a:srgbClr val="333399"/>
                  </a:solidFill>
                  <a:latin typeface="Arial"/>
                </a:rPr>
                <a:t>E.coli</a:t>
              </a: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. Library titer estimation for the constructed librari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8" name=""/>
            <p:cNvGrpSpPr/>
            <p:nvPr/>
          </p:nvGrpSpPr>
          <p:grpSpPr>
            <a:xfrm>
              <a:off x="380880" y="3854520"/>
              <a:ext cx="2286000" cy="1185840"/>
              <a:chOff x="380880" y="3854520"/>
              <a:chExt cx="2286000" cy="1185840"/>
            </a:xfrm>
          </p:grpSpPr>
          <p:sp>
            <p:nvSpPr>
              <p:cNvPr id="49" name=""/>
              <p:cNvSpPr/>
              <p:nvPr/>
            </p:nvSpPr>
            <p:spPr>
              <a:xfrm>
                <a:off x="1447920" y="4735440"/>
                <a:ext cx="0" cy="304920"/>
              </a:xfrm>
              <a:prstGeom prst="line">
                <a:avLst/>
              </a:prstGeom>
              <a:ln w="38160">
                <a:solidFill>
                  <a:srgbClr val="f9340d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80880" y="3854520"/>
                <a:ext cx="2286000" cy="824040"/>
              </a:xfrm>
              <a:prstGeom prst="rect">
                <a:avLst/>
              </a:prstGeom>
              <a:solidFill>
                <a:srgbClr val="d4d4d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893880"/>
                    <a:tab algn="l" pos="1787400"/>
                    <a:tab algn="l" pos="2681280"/>
                    <a:tab algn="l" pos="3575160"/>
                    <a:tab algn="l" pos="4468680"/>
                    <a:tab algn="l" pos="5362560"/>
                    <a:tab algn="l" pos="6256440"/>
                    <a:tab algn="l" pos="7149960"/>
                    <a:tab algn="l" pos="8043840"/>
                    <a:tab algn="l" pos="8937720"/>
                    <a:tab algn="l" pos="9831240"/>
                    <a:tab algn="l" pos="10725120"/>
                  </a:tabLst>
                </a:pPr>
                <a:r>
                  <a:rPr b="0" lang="en-US" sz="1200" spc="-1" strike="noStrike">
                    <a:solidFill>
                      <a:srgbClr val="333399"/>
                    </a:solidFill>
                    <a:latin typeface="Arial"/>
                  </a:rPr>
                  <a:t>Mobilization of the library into yeast, transformation of shuttle vector into </a:t>
                </a:r>
                <a:r>
                  <a:rPr b="0" i="1" lang="en-US" sz="1200" spc="-1" strike="noStrike">
                    <a:solidFill>
                      <a:srgbClr val="333399"/>
                    </a:solidFill>
                    <a:latin typeface="Arial"/>
                  </a:rPr>
                  <a:t>E.coli</a:t>
                </a:r>
                <a:r>
                  <a:rPr b="0" lang="en-US" sz="1200" spc="-1" strike="noStrike">
                    <a:solidFill>
                      <a:srgbClr val="333399"/>
                    </a:solidFill>
                    <a:latin typeface="Arial"/>
                  </a:rPr>
                  <a:t> and  amplification of the library.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"/>
            <p:cNvSpPr/>
            <p:nvPr/>
          </p:nvSpPr>
          <p:spPr>
            <a:xfrm>
              <a:off x="4419720" y="3295800"/>
              <a:ext cx="0" cy="304560"/>
            </a:xfrm>
            <a:prstGeom prst="line">
              <a:avLst/>
            </a:prstGeom>
            <a:ln w="38160">
              <a:solidFill>
                <a:srgbClr val="f9340d"/>
              </a:solidFill>
              <a:miter/>
              <a:tail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352680" y="1512720"/>
              <a:ext cx="2286000" cy="2071800"/>
            </a:xfrm>
            <a:prstGeom prst="rect">
              <a:avLst/>
            </a:prstGeom>
            <a:solidFill>
              <a:srgbClr val="eebf8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00"/>
                </a:spcBef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Treatment and screening yeast transformants for response to salt and drought resistanc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00"/>
                </a:spcBef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00"/>
                </a:spcBef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High throughput quadrapulate screens</a:t>
              </a: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using 96 well grids and replica printing syste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00"/>
                </a:spcBef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00"/>
                </a:spcBef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419720" y="4540320"/>
              <a:ext cx="0" cy="304560"/>
            </a:xfrm>
            <a:prstGeom prst="line">
              <a:avLst/>
            </a:prstGeom>
            <a:ln w="38160">
              <a:solidFill>
                <a:srgbClr val="f9340d"/>
              </a:solidFill>
              <a:miter/>
              <a:tail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352680" y="3641760"/>
              <a:ext cx="2286000" cy="824040"/>
            </a:xfrm>
            <a:prstGeom prst="rect">
              <a:avLst/>
            </a:prstGeom>
            <a:solidFill>
              <a:srgbClr val="cecfb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00"/>
                </a:spcBef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Isolation of yeast transformants tolerant to salt stress (or other related abiotic stres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" name=""/>
            <p:cNvGrpSpPr/>
            <p:nvPr/>
          </p:nvGrpSpPr>
          <p:grpSpPr>
            <a:xfrm>
              <a:off x="3352680" y="1359000"/>
              <a:ext cx="3962520" cy="4406760"/>
              <a:chOff x="3352680" y="1359000"/>
              <a:chExt cx="3962520" cy="4406760"/>
            </a:xfrm>
          </p:grpSpPr>
          <p:grpSp>
            <p:nvGrpSpPr>
              <p:cNvPr id="56" name=""/>
              <p:cNvGrpSpPr/>
              <p:nvPr/>
            </p:nvGrpSpPr>
            <p:grpSpPr>
              <a:xfrm>
                <a:off x="5562720" y="1359000"/>
                <a:ext cx="1752480" cy="4269240"/>
                <a:chOff x="5562720" y="1359000"/>
                <a:chExt cx="1752480" cy="4269240"/>
              </a:xfrm>
            </p:grpSpPr>
            <p:grpSp>
              <p:nvGrpSpPr>
                <p:cNvPr id="57" name=""/>
                <p:cNvGrpSpPr/>
                <p:nvPr/>
              </p:nvGrpSpPr>
              <p:grpSpPr>
                <a:xfrm>
                  <a:off x="5562720" y="1359000"/>
                  <a:ext cx="1752480" cy="4269240"/>
                  <a:chOff x="5562720" y="1359000"/>
                  <a:chExt cx="1752480" cy="4269240"/>
                </a:xfrm>
              </p:grpSpPr>
              <p:sp>
                <p:nvSpPr>
                  <p:cNvPr id="58" name=""/>
                  <p:cNvSpPr/>
                  <p:nvPr/>
                </p:nvSpPr>
                <p:spPr>
                  <a:xfrm>
                    <a:off x="5562720" y="5628240"/>
                    <a:ext cx="304920" cy="0"/>
                  </a:xfrm>
                  <a:prstGeom prst="line">
                    <a:avLst/>
                  </a:prstGeom>
                  <a:ln w="28440">
                    <a:solidFill>
                      <a:srgbClr val="f9340d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"/>
                  <p:cNvSpPr/>
                  <p:nvPr/>
                </p:nvSpPr>
                <p:spPr>
                  <a:xfrm>
                    <a:off x="5867640" y="1359000"/>
                    <a:ext cx="1447560" cy="0"/>
                  </a:xfrm>
                  <a:prstGeom prst="line">
                    <a:avLst/>
                  </a:prstGeom>
                  <a:ln w="12600">
                    <a:solidFill>
                      <a:srgbClr val="f9340d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"/>
                  <p:cNvSpPr/>
                  <p:nvPr/>
                </p:nvSpPr>
                <p:spPr>
                  <a:xfrm>
                    <a:off x="7315200" y="1359000"/>
                    <a:ext cx="0" cy="149760"/>
                  </a:xfrm>
                  <a:prstGeom prst="line">
                    <a:avLst/>
                  </a:prstGeom>
                  <a:ln w="38160">
                    <a:solidFill>
                      <a:srgbClr val="f9340d"/>
                    </a:solidFill>
                    <a:miter/>
                    <a:tailEnd len="med" type="stealth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1" name=""/>
                <p:cNvSpPr/>
                <p:nvPr/>
              </p:nvSpPr>
              <p:spPr>
                <a:xfrm>
                  <a:off x="5867640" y="1359000"/>
                  <a:ext cx="0" cy="4269240"/>
                </a:xfrm>
                <a:prstGeom prst="line">
                  <a:avLst/>
                </a:prstGeom>
                <a:ln w="28440">
                  <a:solidFill>
                    <a:srgbClr val="f934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2" name=""/>
              <p:cNvSpPr/>
              <p:nvPr/>
            </p:nvSpPr>
            <p:spPr>
              <a:xfrm>
                <a:off x="3352680" y="4941720"/>
                <a:ext cx="2286000" cy="824040"/>
              </a:xfrm>
              <a:prstGeom prst="rect">
                <a:avLst/>
              </a:prstGeom>
              <a:solidFill>
                <a:srgbClr val="a2e8fe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300"/>
                  </a:spcBef>
                  <a:tabLst>
                    <a:tab algn="l" pos="0"/>
                    <a:tab algn="l" pos="893880"/>
                    <a:tab algn="l" pos="1787400"/>
                    <a:tab algn="l" pos="2681280"/>
                    <a:tab algn="l" pos="3575160"/>
                    <a:tab algn="l" pos="4468680"/>
                    <a:tab algn="l" pos="5362560"/>
                    <a:tab algn="l" pos="6256440"/>
                    <a:tab algn="l" pos="7149960"/>
                    <a:tab algn="l" pos="8043840"/>
                    <a:tab algn="l" pos="8937720"/>
                    <a:tab algn="l" pos="9831240"/>
                    <a:tab algn="l" pos="10725120"/>
                  </a:tabLst>
                </a:pPr>
                <a:r>
                  <a:rPr b="0" lang="en-US" sz="1200" spc="-1" strike="noStrike">
                    <a:solidFill>
                      <a:srgbClr val="333399"/>
                    </a:solidFill>
                    <a:latin typeface="Arial"/>
                  </a:rPr>
                  <a:t>Re-screening for salt tolerance and stress challenge tests and quality control of screening parameter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" name=""/>
            <p:cNvSpPr/>
            <p:nvPr/>
          </p:nvSpPr>
          <p:spPr>
            <a:xfrm>
              <a:off x="6248520" y="1492200"/>
              <a:ext cx="2286000" cy="824040"/>
            </a:xfrm>
            <a:prstGeom prst="rect">
              <a:avLst/>
            </a:prstGeom>
            <a:solidFill>
              <a:srgbClr val="e5ff9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00"/>
                </a:spcBef>
                <a:tabLst>
                  <a:tab algn="l" pos="0"/>
                  <a:tab algn="l" pos="893880"/>
                  <a:tab algn="l" pos="1787400"/>
                  <a:tab algn="l" pos="2681280"/>
                  <a:tab algn="l" pos="3575160"/>
                  <a:tab algn="l" pos="4468680"/>
                  <a:tab algn="l" pos="5362560"/>
                  <a:tab algn="l" pos="6256440"/>
                  <a:tab algn="l" pos="7149960"/>
                  <a:tab algn="l" pos="8043840"/>
                  <a:tab algn="l" pos="8937720"/>
                  <a:tab algn="l" pos="9831240"/>
                  <a:tab algn="l" pos="10725120"/>
                </a:tabLst>
              </a:pP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Plasmid rescue and sequencing, followed by computational sequence analysis and annot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4" name=""/>
            <p:cNvGrpSpPr/>
            <p:nvPr/>
          </p:nvGrpSpPr>
          <p:grpSpPr>
            <a:xfrm>
              <a:off x="380880" y="1339920"/>
              <a:ext cx="4038840" cy="4343400"/>
              <a:chOff x="380880" y="1339920"/>
              <a:chExt cx="4038840" cy="4343400"/>
            </a:xfrm>
          </p:grpSpPr>
          <p:sp>
            <p:nvSpPr>
              <p:cNvPr id="65" name=""/>
              <p:cNvSpPr/>
              <p:nvPr/>
            </p:nvSpPr>
            <p:spPr>
              <a:xfrm>
                <a:off x="2666880" y="5683320"/>
                <a:ext cx="304920" cy="0"/>
              </a:xfrm>
              <a:prstGeom prst="line">
                <a:avLst/>
              </a:prstGeom>
              <a:ln w="28440">
                <a:solidFill>
                  <a:srgbClr val="f934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6" name=""/>
              <p:cNvGrpSpPr/>
              <p:nvPr/>
            </p:nvGrpSpPr>
            <p:grpSpPr>
              <a:xfrm>
                <a:off x="380880" y="1339920"/>
                <a:ext cx="4038840" cy="4343400"/>
                <a:chOff x="380880" y="1339920"/>
                <a:chExt cx="4038840" cy="4343400"/>
              </a:xfrm>
            </p:grpSpPr>
            <p:sp>
              <p:nvSpPr>
                <p:cNvPr id="67" name=""/>
                <p:cNvSpPr/>
                <p:nvPr/>
              </p:nvSpPr>
              <p:spPr>
                <a:xfrm>
                  <a:off x="2971800" y="1339920"/>
                  <a:ext cx="1447920" cy="0"/>
                </a:xfrm>
                <a:prstGeom prst="line">
                  <a:avLst/>
                </a:prstGeom>
                <a:ln w="12600">
                  <a:solidFill>
                    <a:srgbClr val="f934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8" name=""/>
                <p:cNvGrpSpPr/>
                <p:nvPr/>
              </p:nvGrpSpPr>
              <p:grpSpPr>
                <a:xfrm>
                  <a:off x="380880" y="1339920"/>
                  <a:ext cx="4038840" cy="4343400"/>
                  <a:chOff x="380880" y="1339920"/>
                  <a:chExt cx="4038840" cy="4343400"/>
                </a:xfrm>
              </p:grpSpPr>
              <p:sp>
                <p:nvSpPr>
                  <p:cNvPr id="69" name=""/>
                  <p:cNvSpPr/>
                  <p:nvPr/>
                </p:nvSpPr>
                <p:spPr>
                  <a:xfrm>
                    <a:off x="380880" y="5150160"/>
                    <a:ext cx="2286000" cy="459000"/>
                  </a:xfrm>
                  <a:prstGeom prst="rect">
                    <a:avLst/>
                  </a:prstGeom>
                  <a:solidFill>
                    <a:srgbClr val="c1fbc5"/>
                  </a:solidFill>
                  <a:ln w="12600">
                    <a:solidFill>
                      <a:srgbClr val="c1fbc5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893880"/>
                        <a:tab algn="l" pos="1787400"/>
                        <a:tab algn="l" pos="2681280"/>
                        <a:tab algn="l" pos="3575160"/>
                        <a:tab algn="l" pos="4468680"/>
                        <a:tab algn="l" pos="5362560"/>
                        <a:tab algn="l" pos="6256440"/>
                        <a:tab algn="l" pos="7149960"/>
                        <a:tab algn="l" pos="8043840"/>
                        <a:tab algn="l" pos="8937720"/>
                        <a:tab algn="l" pos="9831240"/>
                        <a:tab algn="l" pos="10725120"/>
                      </a:tabLst>
                    </a:pPr>
                    <a:r>
                      <a:rPr b="0" lang="en-US" sz="1200" spc="-1" strike="noStrike">
                        <a:solidFill>
                          <a:srgbClr val="333399"/>
                        </a:solidFill>
                        <a:latin typeface="Arial"/>
                      </a:rPr>
                      <a:t>Transformation of yeast and selection of the transformants 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"/>
                  <p:cNvSpPr/>
                  <p:nvPr/>
                </p:nvSpPr>
                <p:spPr>
                  <a:xfrm>
                    <a:off x="2971800" y="1339920"/>
                    <a:ext cx="0" cy="4343400"/>
                  </a:xfrm>
                  <a:prstGeom prst="line">
                    <a:avLst/>
                  </a:prstGeom>
                  <a:ln w="28440">
                    <a:solidFill>
                      <a:srgbClr val="f9340d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"/>
                  <p:cNvSpPr/>
                  <p:nvPr/>
                </p:nvSpPr>
                <p:spPr>
                  <a:xfrm>
                    <a:off x="4419720" y="1339920"/>
                    <a:ext cx="0" cy="152640"/>
                  </a:xfrm>
                  <a:prstGeom prst="line">
                    <a:avLst/>
                  </a:prstGeom>
                  <a:ln w="38160">
                    <a:solidFill>
                      <a:srgbClr val="f9340d"/>
                    </a:solidFill>
                    <a:miter/>
                    <a:tailEnd len="med" type="stealth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72" name=""/>
            <p:cNvGrpSpPr/>
            <p:nvPr/>
          </p:nvGrpSpPr>
          <p:grpSpPr>
            <a:xfrm>
              <a:off x="2819160" y="2482560"/>
              <a:ext cx="533160" cy="2895840"/>
              <a:chOff x="2819160" y="2482560"/>
              <a:chExt cx="533160" cy="2895840"/>
            </a:xfrm>
          </p:grpSpPr>
          <p:sp>
            <p:nvSpPr>
              <p:cNvPr id="73" name=""/>
              <p:cNvSpPr/>
              <p:nvPr/>
            </p:nvSpPr>
            <p:spPr>
              <a:xfrm flipV="1">
                <a:off x="2819520" y="2482560"/>
                <a:ext cx="0" cy="2895480"/>
              </a:xfrm>
              <a:prstGeom prst="line">
                <a:avLst/>
              </a:prstGeom>
              <a:ln w="28440">
                <a:solidFill>
                  <a:srgbClr val="66ff33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4" name=""/>
              <p:cNvGrpSpPr/>
              <p:nvPr/>
            </p:nvGrpSpPr>
            <p:grpSpPr>
              <a:xfrm>
                <a:off x="2819160" y="2482920"/>
                <a:ext cx="533160" cy="2895480"/>
                <a:chOff x="2819160" y="2482920"/>
                <a:chExt cx="533160" cy="2895480"/>
              </a:xfrm>
            </p:grpSpPr>
            <p:sp>
              <p:nvSpPr>
                <p:cNvPr id="75" name=""/>
                <p:cNvSpPr/>
                <p:nvPr/>
              </p:nvSpPr>
              <p:spPr>
                <a:xfrm flipH="1">
                  <a:off x="2819160" y="4083120"/>
                  <a:ext cx="533160" cy="0"/>
                </a:xfrm>
                <a:prstGeom prst="line">
                  <a:avLst/>
                </a:prstGeom>
                <a:ln w="28440">
                  <a:solidFill>
                    <a:srgbClr val="66ff33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 flipH="1">
                  <a:off x="2819160" y="5378400"/>
                  <a:ext cx="533160" cy="0"/>
                </a:xfrm>
                <a:prstGeom prst="line">
                  <a:avLst/>
                </a:prstGeom>
                <a:ln w="28440">
                  <a:solidFill>
                    <a:srgbClr val="66ff33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2819520" y="2482920"/>
                  <a:ext cx="380880" cy="0"/>
                </a:xfrm>
                <a:prstGeom prst="line">
                  <a:avLst/>
                </a:prstGeom>
                <a:ln w="28440">
                  <a:solidFill>
                    <a:srgbClr val="66ff33"/>
                  </a:solidFill>
                  <a:prstDash val="sysDot"/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8" name=""/>
            <p:cNvSpPr/>
            <p:nvPr/>
          </p:nvSpPr>
          <p:spPr>
            <a:xfrm>
              <a:off x="409680" y="762120"/>
              <a:ext cx="2057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ibrary generation into yeast expression syste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21T05:45:52Z</dcterms:created>
  <dc:creator>tjohnson</dc:creator>
  <dc:description/>
  <dc:language>en-US</dc:language>
  <cp:lastModifiedBy>sudhakar.tangirala</cp:lastModifiedBy>
  <dcterms:modified xsi:type="dcterms:W3CDTF">2010-03-08T05:14:17Z</dcterms:modified>
  <cp:revision>23</cp:revision>
  <dc:subject/>
  <dc:title>Slide 1</dc:title>
</cp:coreProperties>
</file>